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B6D91C-316F-FD4F-ADA4-DBC40D83720C}" v="1" dt="2023-06-15T21:04:54.66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170" d="100"/>
          <a:sy n="170" d="100"/>
        </p:scale>
        <p:origin x="163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g, Swati" userId="91dd154a-0afd-44a5-9ccb-86cf856e14e9" providerId="ADAL" clId="{17129001-8B29-A14C-9BF1-5DF7FCFAF7C8}"/>
    <pc:docChg chg="custSel modSld">
      <pc:chgData name="Garg, Swati" userId="91dd154a-0afd-44a5-9ccb-86cf856e14e9" providerId="ADAL" clId="{17129001-8B29-A14C-9BF1-5DF7FCFAF7C8}" dt="2023-06-16T20:54:58.879" v="1" actId="20577"/>
      <pc:docMkLst>
        <pc:docMk/>
      </pc:docMkLst>
      <pc:sldChg chg="modSp mod">
        <pc:chgData name="Garg, Swati" userId="91dd154a-0afd-44a5-9ccb-86cf856e14e9" providerId="ADAL" clId="{17129001-8B29-A14C-9BF1-5DF7FCFAF7C8}" dt="2023-06-16T20:54:58.879" v="1" actId="20577"/>
        <pc:sldMkLst>
          <pc:docMk/>
          <pc:sldMk cId="2720126415" sldId="256"/>
        </pc:sldMkLst>
        <pc:graphicFrameChg chg="modGraphic">
          <ac:chgData name="Garg, Swati" userId="91dd154a-0afd-44a5-9ccb-86cf856e14e9" providerId="ADAL" clId="{17129001-8B29-A14C-9BF1-5DF7FCFAF7C8}" dt="2023-06-16T20:54:58.879" v="1" actId="20577"/>
          <ac:graphicFrameMkLst>
            <pc:docMk/>
            <pc:sldMk cId="2720126415" sldId="256"/>
            <ac:graphicFrameMk id="9" creationId="{F60AFCD6-D67C-1E72-6520-8E62D919C8CC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D99884-3D9D-BB49-A9EC-4613E24F85DF}" type="datetimeFigureOut">
              <a:rPr lang="en-US" smtClean="0"/>
              <a:t>6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734ED8-D4C8-2946-A54E-C029A08C9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432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734ED8-D4C8-2946-A54E-C029A08C989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018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118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08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423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187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69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60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898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749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275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124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673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76DAC-0741-A146-95F2-5B3BB77FDFE0}" type="datetimeFigureOut">
              <a:rPr lang="en-US" smtClean="0"/>
              <a:t>6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93DE7-1D99-944D-88C5-E0E18B146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344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7C17A3B4-4113-372C-280F-1626C23749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3109407"/>
              </p:ext>
            </p:extLst>
          </p:nvPr>
        </p:nvGraphicFramePr>
        <p:xfrm>
          <a:off x="291068" y="174188"/>
          <a:ext cx="2919965" cy="8565793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05365">
                  <a:extLst>
                    <a:ext uri="{9D8B030D-6E8A-4147-A177-3AD203B41FA5}">
                      <a16:colId xmlns:a16="http://schemas.microsoft.com/office/drawing/2014/main" val="4239469604"/>
                    </a:ext>
                  </a:extLst>
                </a:gridCol>
                <a:gridCol w="776177">
                  <a:extLst>
                    <a:ext uri="{9D8B030D-6E8A-4147-A177-3AD203B41FA5}">
                      <a16:colId xmlns:a16="http://schemas.microsoft.com/office/drawing/2014/main" val="3598614896"/>
                    </a:ext>
                  </a:extLst>
                </a:gridCol>
                <a:gridCol w="590106">
                  <a:extLst>
                    <a:ext uri="{9D8B030D-6E8A-4147-A177-3AD203B41FA5}">
                      <a16:colId xmlns:a16="http://schemas.microsoft.com/office/drawing/2014/main" val="3316549430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2448288811"/>
                    </a:ext>
                  </a:extLst>
                </a:gridCol>
                <a:gridCol w="510363">
                  <a:extLst>
                    <a:ext uri="{9D8B030D-6E8A-4147-A177-3AD203B41FA5}">
                      <a16:colId xmlns:a16="http://schemas.microsoft.com/office/drawing/2014/main" val="568646255"/>
                    </a:ext>
                  </a:extLst>
                </a:gridCol>
              </a:tblGrid>
              <a:tr h="3733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Antigen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</a:rPr>
                        <a:t>Clinical Trial number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Additional featur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AR product na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AR cell typ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468713560"/>
                  </a:ext>
                </a:extLst>
              </a:tr>
              <a:tr h="126347">
                <a:tc rowSpan="2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33/ SIGLEC-3/Gp6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732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8451942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486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93797718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9441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-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82450551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150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15788810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457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11617646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1268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18722114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8355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35394924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6721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54898533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9717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57870153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799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854722333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0085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78547889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18649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589583194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0160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628306259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NCT0510515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ARIC~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C-DARIC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65144155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8850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 dirty="0" err="1">
                          <a:effectLst/>
                        </a:rPr>
                        <a:t>γδ</a:t>
                      </a:r>
                      <a:r>
                        <a:rPr lang="en-US" sz="800" u="none" strike="noStrike" dirty="0">
                          <a:effectLst/>
                        </a:rPr>
                        <a:t>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305114959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9272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b IL-15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PRGN-30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126397916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6547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CAR-AM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095690974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6014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QN-02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678795318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6650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QN-02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70614234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91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48232615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226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92181306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4734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293485906"/>
                  </a:ext>
                </a:extLst>
              </a:tr>
              <a:tr h="126347">
                <a:tc rowSpan="25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123/ IL3R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3883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 dirty="0" err="1">
                          <a:effectLst/>
                        </a:rPr>
                        <a:t>γδ</a:t>
                      </a:r>
                      <a:r>
                        <a:rPr lang="en-US" sz="800" u="none" strike="noStrike" dirty="0">
                          <a:effectLst/>
                        </a:rPr>
                        <a:t>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93873737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7963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83878995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5855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425288586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5995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08442663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1146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GF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486907958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5746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JD0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42122472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0148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94340891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3186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339923679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5569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87319125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6235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337418095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2721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34824759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2659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086540762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570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versal C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PRX0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16216798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1594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GF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519877267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1060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versal C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UCART12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806400284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1902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versal C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CART123v1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192649265"/>
                  </a:ext>
                </a:extLst>
              </a:tr>
              <a:tr h="2498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2302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 (TM123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CAR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922425434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6728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72140379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7661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84061402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6783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82441313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1562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71279965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5136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50520511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91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46601168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226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35818283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4734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466491697"/>
                  </a:ext>
                </a:extLst>
              </a:tr>
              <a:tr h="126347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LL1/ CLEC12A/ CD371/ MIC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672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659264302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672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88881382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6315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Combi*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01991840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0108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3067269673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2191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CD2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452932887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525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37065244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8849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807296830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7894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KITE-2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030590576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9239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362658608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7957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2811443638"/>
                  </a:ext>
                </a:extLst>
              </a:tr>
              <a:tr h="1263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226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Combi*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184" marR="3184" marT="3184" marB="0" anchor="ctr"/>
                </a:tc>
                <a:extLst>
                  <a:ext uri="{0D108BD9-81ED-4DB2-BD59-A6C34878D82A}">
                    <a16:rowId xmlns:a16="http://schemas.microsoft.com/office/drawing/2014/main" val="1204337230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F60AFCD6-D67C-1E72-6520-8E62D919C8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0808111"/>
              </p:ext>
            </p:extLst>
          </p:nvPr>
        </p:nvGraphicFramePr>
        <p:xfrm>
          <a:off x="3478173" y="169509"/>
          <a:ext cx="3088759" cy="8570472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93985">
                  <a:extLst>
                    <a:ext uri="{9D8B030D-6E8A-4147-A177-3AD203B41FA5}">
                      <a16:colId xmlns:a16="http://schemas.microsoft.com/office/drawing/2014/main" val="1551809441"/>
                    </a:ext>
                  </a:extLst>
                </a:gridCol>
                <a:gridCol w="814260">
                  <a:extLst>
                    <a:ext uri="{9D8B030D-6E8A-4147-A177-3AD203B41FA5}">
                      <a16:colId xmlns:a16="http://schemas.microsoft.com/office/drawing/2014/main" val="1371978473"/>
                    </a:ext>
                  </a:extLst>
                </a:gridCol>
                <a:gridCol w="543114">
                  <a:extLst>
                    <a:ext uri="{9D8B030D-6E8A-4147-A177-3AD203B41FA5}">
                      <a16:colId xmlns:a16="http://schemas.microsoft.com/office/drawing/2014/main" val="3053102897"/>
                    </a:ext>
                  </a:extLst>
                </a:gridCol>
                <a:gridCol w="618700">
                  <a:extLst>
                    <a:ext uri="{9D8B030D-6E8A-4147-A177-3AD203B41FA5}">
                      <a16:colId xmlns:a16="http://schemas.microsoft.com/office/drawing/2014/main" val="51068027"/>
                    </a:ext>
                  </a:extLst>
                </a:gridCol>
                <a:gridCol w="618700">
                  <a:extLst>
                    <a:ext uri="{9D8B030D-6E8A-4147-A177-3AD203B41FA5}">
                      <a16:colId xmlns:a16="http://schemas.microsoft.com/office/drawing/2014/main" val="1427276869"/>
                    </a:ext>
                  </a:extLst>
                </a:gridCol>
              </a:tblGrid>
              <a:tr h="2533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Antigen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linical Trial numb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Additional featur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AR product na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AR cell typ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256383052"/>
                  </a:ext>
                </a:extLst>
              </a:tr>
              <a:tr h="169688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FLT3/ CD135/ FLK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0237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856157566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669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I-1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675755705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450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AA05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136458325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9040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G5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95496241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NCT050178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TAA05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540143327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324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AA05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120228121"/>
                  </a:ext>
                </a:extLst>
              </a:tr>
              <a:tr h="2430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44v6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0973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HSV-TK~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LM-CAR4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501923657"/>
                  </a:ext>
                </a:extLst>
              </a:tr>
              <a:tr h="16968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ADGRE2/</a:t>
                      </a:r>
                    </a:p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9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636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31861129"/>
                  </a:ext>
                </a:extLst>
              </a:tr>
              <a:tr h="243069"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9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7481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DCLEC.syn1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021172260"/>
                  </a:ext>
                </a:extLst>
              </a:tr>
              <a:tr h="1696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</a:rPr>
                        <a:t>IL1RA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1690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208217697"/>
                  </a:ext>
                </a:extLst>
              </a:tr>
              <a:tr h="1696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</a:rPr>
                        <a:t>LewisY</a:t>
                      </a:r>
                      <a:r>
                        <a:rPr lang="en-US" sz="800" b="1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17163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241835531"/>
                  </a:ext>
                </a:extLst>
              </a:tr>
              <a:tr h="2430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</a:rPr>
                        <a:t>LILRB4/ ILT3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8039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239762898"/>
                  </a:ext>
                </a:extLst>
              </a:tr>
              <a:tr h="1696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</a:rPr>
                        <a:t>SIGLEC-6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881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810328905"/>
                  </a:ext>
                </a:extLst>
              </a:tr>
              <a:tr h="169688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19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7964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</a:rPr>
                        <a:t>γδ</a:t>
                      </a:r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 dirty="0" err="1">
                          <a:effectLst/>
                        </a:rPr>
                        <a:t>γδ</a:t>
                      </a:r>
                      <a:r>
                        <a:rPr lang="en-US" sz="800" u="none" strike="noStrike" dirty="0">
                          <a:effectLst/>
                        </a:rPr>
                        <a:t>T Cel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663008913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2571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71642423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8968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534349216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5136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961404533"/>
                  </a:ext>
                </a:extLst>
              </a:tr>
              <a:tr h="16968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7624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8537410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0333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114541666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542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74087858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7427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NK-9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017512136"/>
                  </a:ext>
                </a:extLst>
              </a:tr>
              <a:tr h="2430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3778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R, dTRA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WU-CART-0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996451794"/>
                  </a:ext>
                </a:extLst>
              </a:tr>
              <a:tr h="21329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</a:rPr>
                        <a:t>CD70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0924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CB-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66612980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6622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365574283"/>
                  </a:ext>
                </a:extLst>
              </a:tr>
              <a:tr h="1696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7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7668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IM-7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635835369"/>
                  </a:ext>
                </a:extLst>
              </a:tr>
              <a:tr h="16968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276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7312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TAA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</a:rPr>
                        <a:t>γδ</a:t>
                      </a:r>
                      <a:r>
                        <a:rPr lang="en-US" sz="800" u="none" strike="noStrike">
                          <a:effectLst/>
                        </a:rPr>
                        <a:t>T Ce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266143111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69294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AA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793598275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7221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u="none" strike="noStrike">
                          <a:effectLst/>
                        </a:rPr>
                        <a:t>γδ</a:t>
                      </a:r>
                      <a:r>
                        <a:rPr lang="en-US" sz="800" u="none" strike="noStrike">
                          <a:effectLst/>
                        </a:rPr>
                        <a:t>T Ce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39318209"/>
                  </a:ext>
                </a:extLst>
              </a:tr>
              <a:tr h="169688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3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91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52549562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396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471962987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3510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ART-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442760966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4425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ART-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816895661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226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060771536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4734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98324251"/>
                  </a:ext>
                </a:extLst>
              </a:tr>
              <a:tr h="169688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NKG2D/ KLRK1/ CD31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7348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054622629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NCT0465800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16398432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6239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b IL-15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X1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713835133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52479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737966332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6127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KR-2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042038924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22038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M-C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3013899128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0184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129127884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41676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703516430"/>
                  </a:ext>
                </a:extLst>
              </a:tr>
              <a:tr h="16968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56 or Muc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91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4088016323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226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mbi*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1678190662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4734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2083592606"/>
                  </a:ext>
                </a:extLst>
              </a:tr>
              <a:tr h="16968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CD34 or CD11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T032914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717933869"/>
                  </a:ext>
                </a:extLst>
              </a:tr>
              <a:tr h="1696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NCT0347345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99" marR="3899" marT="3899" marB="0" anchor="ctr"/>
                </a:tc>
                <a:extLst>
                  <a:ext uri="{0D108BD9-81ED-4DB2-BD59-A6C34878D82A}">
                    <a16:rowId xmlns:a16="http://schemas.microsoft.com/office/drawing/2014/main" val="820296558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F2E1BA64-0893-0576-7F8A-5D3CA9CB4F08}"/>
              </a:ext>
            </a:extLst>
          </p:cNvPr>
          <p:cNvSpPr txBox="1"/>
          <p:nvPr/>
        </p:nvSpPr>
        <p:spPr>
          <a:xfrm>
            <a:off x="291068" y="8739981"/>
            <a:ext cx="6275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bbreviations: </a:t>
            </a:r>
            <a:r>
              <a:rPr lang="en-US" sz="8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bi: combinatorial; DARIC: Dimerizing Agent Regulated Immunoreceptor Complex; mbIL15: membrane bound IL15; </a:t>
            </a:r>
            <a:r>
              <a:rPr lang="en-US" sz="800" u="none" strike="noStrike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</a:t>
            </a:r>
            <a:r>
              <a:rPr lang="en-US" sz="8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recombinant antibody derivative; FR, </a:t>
            </a:r>
            <a:r>
              <a:rPr lang="en-US" sz="800" u="none" strike="noStrike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TRAC</a:t>
            </a:r>
            <a:r>
              <a:rPr lang="en-US" sz="8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Fratricide resistant CD7 and TRAC deleted; CB: cord blood</a:t>
            </a:r>
            <a:endParaRPr lang="en-US" sz="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2441E6-B72F-F323-5285-BB553A9ECC41}"/>
              </a:ext>
            </a:extLst>
          </p:cNvPr>
          <p:cNvSpPr txBox="1"/>
          <p:nvPr/>
        </p:nvSpPr>
        <p:spPr>
          <a:xfrm>
            <a:off x="291068" y="9035727"/>
            <a:ext cx="62758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binatorial: NCT05467254: CLL1+CD33 CART; NCT03631576: CLL1+CD123 CART; NCT04010877:  CLL-1, CD33 and/or CD123; NCT03222674: Muc1/CLL1/CD33/CD38/CD56/CD123; NCT05248685: Dual CD33/CLL1 CAR T; NCT05748197: ADCLEC.syn1 CAR T; NCT05215015: CD33/CLL1; NCT05016063: Dual CD33-CLL1 CAR-T; NCT05654779:  Dual CD33/CLL1 CAR T;  NCT04156256: CD123-CD33 </a:t>
            </a:r>
            <a:r>
              <a:rPr lang="en-US" sz="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AR</a:t>
            </a:r>
            <a:r>
              <a:rPr lang="en-US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 cells, NCT03795779: CLL1-CD33 </a:t>
            </a:r>
            <a:r>
              <a:rPr lang="en-US" sz="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AR</a:t>
            </a:r>
            <a:r>
              <a:rPr lang="en-US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141D1E-2000-A7E3-A3D1-6E0446360B01}"/>
              </a:ext>
            </a:extLst>
          </p:cNvPr>
          <p:cNvSpPr txBox="1"/>
          <p:nvPr/>
        </p:nvSpPr>
        <p:spPr>
          <a:xfrm>
            <a:off x="340241" y="9614629"/>
            <a:ext cx="6275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~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off switch for cytotoxicity prevention</a:t>
            </a:r>
            <a:endParaRPr lang="en-US" sz="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0126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</TotalTime>
  <Words>538</Words>
  <Application>Microsoft Macintosh PowerPoint</Application>
  <PresentationFormat>A4 Paper (210x297 mm)</PresentationFormat>
  <Paragraphs>3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g, Swati</dc:creator>
  <cp:lastModifiedBy>Garg, Swati</cp:lastModifiedBy>
  <cp:revision>2</cp:revision>
  <dcterms:created xsi:type="dcterms:W3CDTF">2023-06-15T20:43:21Z</dcterms:created>
  <dcterms:modified xsi:type="dcterms:W3CDTF">2023-06-16T20:55:06Z</dcterms:modified>
</cp:coreProperties>
</file>